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8.xml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3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22.xml"/>
  <Override ContentType="application/vnd.openxmlformats-officedocument.presentationml.notesSlide+xml" PartName="/ppt/notesSlides/notesSlide9.xml"/>
  <Override ContentType="application/vnd.openxmlformats-officedocument.presentationml.notesSlide+xml" PartName="/ppt/notesSlides/notesSlide15.xml"/>
  <Override ContentType="application/vnd.openxmlformats-officedocument.presentationml.notesSlide+xml" PartName="/ppt/notesSlides/notesSlide7.xml"/>
  <Override ContentType="application/vnd.openxmlformats-officedocument.presentationml.notesSlide+xml" PartName="/ppt/notesSlides/notesSlide11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12.xml"/>
  <Override ContentType="application/vnd.openxmlformats-officedocument.presentationml.notesSlide+xml" PartName="/ppt/notesSlides/notesSlide20.xml"/>
  <Override ContentType="application/vnd.openxmlformats-officedocument.presentationml.notesSlide+xml" PartName="/ppt/notesSlides/notesSlide17.xml"/>
  <Override ContentType="application/vnd.openxmlformats-officedocument.presentationml.notesSlide+xml" PartName="/ppt/notesSlides/notesSlide19.xml"/>
  <Override ContentType="application/vnd.openxmlformats-officedocument.presentationml.notesSlide+xml" PartName="/ppt/notesSlides/notesSlide16.xml"/>
  <Override ContentType="application/vnd.openxmlformats-officedocument.presentationml.notesSlide+xml" PartName="/ppt/notesSlides/notesSlide21.xml"/>
  <Override ContentType="application/vnd.openxmlformats-officedocument.presentationml.notesSlide+xml" PartName="/ppt/notesSlides/notesSlide8.xml"/>
  <Override ContentType="application/vnd.openxmlformats-officedocument.presentationml.notesSlide+xml" PartName="/ppt/notesSlides/notesSlide14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4.xml"/>
  <Override ContentType="application/vnd.openxmlformats-officedocument.presentationml.notesSlide+xml" PartName="/ppt/notesSlides/notesSlide10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4.xml"/>
  <Override ContentType="application/vnd.openxmlformats-officedocument.presentationml.slide+xml" PartName="/ppt/slides/slide18.xml"/>
  <Override ContentType="application/vnd.openxmlformats-officedocument.presentationml.slide+xml" PartName="/ppt/slides/slide11.xml"/>
  <Override ContentType="application/vnd.openxmlformats-officedocument.presentationml.slide+xml" PartName="/ppt/slides/slide22.xml"/>
  <Override ContentType="application/vnd.openxmlformats-officedocument.presentationml.slide+xml" PartName="/ppt/slides/slide1.xml"/>
  <Override ContentType="application/vnd.openxmlformats-officedocument.presentationml.slide+xml" PartName="/ppt/slides/slide19.xml"/>
  <Override ContentType="application/vnd.openxmlformats-officedocument.presentationml.slide+xml" PartName="/ppt/slides/slide3.xml"/>
  <Override ContentType="application/vnd.openxmlformats-officedocument.presentationml.slide+xml" PartName="/ppt/slides/slide9.xml"/>
  <Override ContentType="application/vnd.openxmlformats-officedocument.presentationml.slide+xml" PartName="/ppt/slides/slide13.xml"/>
  <Override ContentType="application/vnd.openxmlformats-officedocument.presentationml.slide+xml" PartName="/ppt/slides/slide5.xml"/>
  <Override ContentType="application/vnd.openxmlformats-officedocument.presentationml.slide+xml" PartName="/ppt/slides/slide7.xml"/>
  <Override ContentType="application/vnd.openxmlformats-officedocument.presentationml.slide+xml" PartName="/ppt/slides/slide15.xml"/>
  <Override ContentType="application/vnd.openxmlformats-officedocument.presentationml.slide+xml" PartName="/ppt/slides/slide12.xml"/>
  <Override ContentType="application/vnd.openxmlformats-officedocument.presentationml.slide+xml" PartName="/ppt/slides/slide17.xml"/>
  <Override ContentType="application/vnd.openxmlformats-officedocument.presentationml.slide+xml" PartName="/ppt/slides/slide20.xml"/>
  <Override ContentType="application/vnd.openxmlformats-officedocument.presentationml.slide+xml" PartName="/ppt/slides/slide21.xml"/>
  <Override ContentType="application/vnd.openxmlformats-officedocument.presentationml.slide+xml" PartName="/ppt/slides/slide10.xml"/>
  <Override ContentType="application/vnd.openxmlformats-officedocument.presentationml.slide+xml" PartName="/ppt/slides/slide2.xml"/>
  <Override ContentType="application/vnd.openxmlformats-officedocument.presentationml.slide+xml" PartName="/ppt/slides/slide6.xml"/>
  <Override ContentType="application/vnd.openxmlformats-officedocument.presentationml.slide+xml" PartName="/ppt/slides/slide16.xml"/>
  <Override ContentType="application/vnd.openxmlformats-officedocument.presentationml.slide+xml" PartName="/ppt/slides/slide8.xml"/>
  <Override ContentType="application/vnd.openxmlformats-officedocument.presentationml.slide+xml" PartName="/ppt/slides/slide14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  <p:sldId id="257" r:id="rId7"/>
    <p:sldId id="258" r:id="rId8"/>
    <p:sldId id="259" r:id="rId9"/>
    <p:sldId id="260" r:id="rId10"/>
    <p:sldId id="261" r:id="rId11"/>
    <p:sldId id="262" r:id="rId12"/>
    <p:sldId id="263" r:id="rId13"/>
    <p:sldId id="264" r:id="rId14"/>
    <p:sldId id="265" r:id="rId15"/>
    <p:sldId id="266" r:id="rId16"/>
    <p:sldId id="267" r:id="rId17"/>
    <p:sldId id="268" r:id="rId18"/>
    <p:sldId id="269" r:id="rId19"/>
    <p:sldId id="270" r:id="rId20"/>
    <p:sldId id="271" r:id="rId21"/>
    <p:sldId id="272" r:id="rId22"/>
    <p:sldId id="273" r:id="rId23"/>
    <p:sldId id="274" r:id="rId24"/>
    <p:sldId id="275" r:id="rId25"/>
    <p:sldId id="276" r:id="rId26"/>
    <p:sldId id="277" r:id="rId27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20" Type="http://schemas.openxmlformats.org/officeDocument/2006/relationships/slide" Target="slides/slide15.xml"/><Relationship Id="rId22" Type="http://schemas.openxmlformats.org/officeDocument/2006/relationships/slide" Target="slides/slide17.xml"/><Relationship Id="rId21" Type="http://schemas.openxmlformats.org/officeDocument/2006/relationships/slide" Target="slides/slide16.xml"/><Relationship Id="rId24" Type="http://schemas.openxmlformats.org/officeDocument/2006/relationships/slide" Target="slides/slide19.xml"/><Relationship Id="rId23" Type="http://schemas.openxmlformats.org/officeDocument/2006/relationships/slide" Target="slides/slide18.xml"/><Relationship Id="rId1" Type="http://schemas.openxmlformats.org/officeDocument/2006/relationships/theme" Target="theme/theme2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26" Type="http://schemas.openxmlformats.org/officeDocument/2006/relationships/slide" Target="slides/slide21.xml"/><Relationship Id="rId25" Type="http://schemas.openxmlformats.org/officeDocument/2006/relationships/slide" Target="slides/slide20.xml"/><Relationship Id="rId27" Type="http://schemas.openxmlformats.org/officeDocument/2006/relationships/slide" Target="slides/slide22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Relationship Id="rId11" Type="http://schemas.openxmlformats.org/officeDocument/2006/relationships/slide" Target="slides/slide6.xml"/><Relationship Id="rId10" Type="http://schemas.openxmlformats.org/officeDocument/2006/relationships/slide" Target="slides/slide5.xml"/><Relationship Id="rId13" Type="http://schemas.openxmlformats.org/officeDocument/2006/relationships/slide" Target="slides/slide8.xml"/><Relationship Id="rId12" Type="http://schemas.openxmlformats.org/officeDocument/2006/relationships/slide" Target="slides/slide7.xml"/><Relationship Id="rId15" Type="http://schemas.openxmlformats.org/officeDocument/2006/relationships/slide" Target="slides/slide10.xml"/><Relationship Id="rId14" Type="http://schemas.openxmlformats.org/officeDocument/2006/relationships/slide" Target="slides/slide9.xml"/><Relationship Id="rId17" Type="http://schemas.openxmlformats.org/officeDocument/2006/relationships/slide" Target="slides/slide12.xml"/><Relationship Id="rId16" Type="http://schemas.openxmlformats.org/officeDocument/2006/relationships/slide" Target="slides/slide11.xml"/><Relationship Id="rId19" Type="http://schemas.openxmlformats.org/officeDocument/2006/relationships/slide" Target="slides/slide14.xml"/><Relationship Id="rId18" Type="http://schemas.openxmlformats.org/officeDocument/2006/relationships/slide" Target="slides/slide1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350dbfc17a4_0_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350dbfc17a4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5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g350dbfc17a4_0_36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7" name="Google Shape;97;g350dbfc17a4_0_3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00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Google Shape;101;g350dbfc17a4_0_4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2" name="Google Shape;102;g350dbfc17a4_0_4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05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g350dbfc17a4_0_44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7" name="Google Shape;107;g350dbfc17a4_0_4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0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Google Shape;111;g350dbfc17a4_0_48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2" name="Google Shape;112;g350dbfc17a4_0_4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6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g350dbfc17a4_0_5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8" name="Google Shape;118;g350dbfc17a4_0_5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21" name="Shape 1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Google Shape;122;g350dbfc17a4_0_57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3" name="Google Shape;123;g350dbfc17a4_0_5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26" name="Shape 1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Google Shape;127;g350dbfc17a4_0_61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8" name="Google Shape;128;g350dbfc17a4_0_6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31" name="Shape 1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Google Shape;132;g350dbfc17a4_0_65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3" name="Google Shape;133;g350dbfc17a4_0_6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36" name="Shape 1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Google Shape;137;g350dbfc17a4_0_69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8" name="Google Shape;138;g350dbfc17a4_0_6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41" name="Shape 1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Google Shape;142;g350dbfc17a4_0_7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43" name="Google Shape;143;g350dbfc17a4_0_7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5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g350dbfc17a4_0_4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7" name="Google Shape;57;g350dbfc17a4_0_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Table 2.0: Risk of Bias and Quality Assessment of Included Studies Using QUADAS-2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GB">
                <a:solidFill>
                  <a:schemeClr val="dk1"/>
                </a:solidFill>
              </a:rPr>
              <a:t>This table summarizes the quality assessment results for each study using the QUADAS-2 tool, showing risk of bias across domains (patient selection, index test, reference standard, and flow and timing) and highlighting any applicability concerns.</a:t>
            </a:r>
            <a:endParaRPr/>
          </a:p>
        </p:txBody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46" name="Shape 1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g350dbfc17a4_0_77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48" name="Google Shape;148;g350dbfc17a4_0_7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51" name="Shape 1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Google Shape;152;g350dbfc17a4_0_81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53" name="Google Shape;153;g350dbfc17a4_0_8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56" name="Shape 1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Google Shape;157;g350dbfc17a4_0_85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58" name="Google Shape;158;g350dbfc17a4_0_8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60" name="Shape 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Google Shape;61;g350dbfc17a4_0_8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2" name="Google Shape;62;g350dbfc17a4_0_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65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g350dbfc17a4_0_12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7" name="Google Shape;67;g350dbfc17a4_0_1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70" name="Shape 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Google Shape;71;g350dbfc17a4_0_16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2" name="Google Shape;72;g350dbfc17a4_0_1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75" name="Shape 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Google Shape;76;g350dbfc17a4_0_2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7" name="Google Shape;77;g350dbfc17a4_0_2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g350dbfc17a4_0_24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2" name="Google Shape;82;g350dbfc17a4_0_2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5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g350dbfc17a4_0_28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7" name="Google Shape;87;g350dbfc17a4_0_2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0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Google Shape;91;g350dbfc17a4_0_32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2" name="Google Shape;92;g350dbfc17a4_0_3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-GB">
                <a:solidFill>
                  <a:schemeClr val="dk1"/>
                </a:solidFill>
              </a:rPr>
              <a:t>Supplementary Table 1.1: Detailed Characteristics of Each Biomarker Included. 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>
                <a:solidFill>
                  <a:schemeClr val="dk1"/>
                </a:solidFill>
              </a:rPr>
              <a:t>This table provides an in-depth overview of each biomarker characteristics, including study design, sample type, population details, and key diagnostic parameters such as sensitivity, specificity, and AUC values across diagnostic phases.</a:t>
            </a:r>
            <a:endParaRPr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.xml"/></Relationships>
</file>

<file path=ppt/slides/_rels/slide1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0.xml"/><Relationship Id="rId3" Type="http://schemas.openxmlformats.org/officeDocument/2006/relationships/image" Target="../media/image15.png"/></Relationships>
</file>

<file path=ppt/slides/_rels/slide1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12.png"/></Relationships>
</file>

<file path=ppt/slides/_rels/slide1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2.xml"/><Relationship Id="rId3" Type="http://schemas.openxmlformats.org/officeDocument/2006/relationships/image" Target="../media/image13.png"/></Relationships>
</file>

<file path=ppt/slides/_rels/slide1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3.xml"/><Relationship Id="rId3" Type="http://schemas.openxmlformats.org/officeDocument/2006/relationships/image" Target="../media/image11.png"/><Relationship Id="rId4" Type="http://schemas.openxmlformats.org/officeDocument/2006/relationships/image" Target="../media/image2.png"/></Relationships>
</file>

<file path=ppt/slides/_rels/slide1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4.xml"/><Relationship Id="rId3" Type="http://schemas.openxmlformats.org/officeDocument/2006/relationships/image" Target="../media/image4.png"/></Relationships>
</file>

<file path=ppt/slides/_rels/slide1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5.xml"/><Relationship Id="rId3" Type="http://schemas.openxmlformats.org/officeDocument/2006/relationships/image" Target="../media/image14.png"/></Relationships>
</file>

<file path=ppt/slides/_rels/slide1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6.xml"/><Relationship Id="rId3" Type="http://schemas.openxmlformats.org/officeDocument/2006/relationships/image" Target="../media/image7.png"/></Relationships>
</file>

<file path=ppt/slides/_rels/slide1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7.xml"/><Relationship Id="rId3" Type="http://schemas.openxmlformats.org/officeDocument/2006/relationships/image" Target="../media/image8.png"/></Relationships>
</file>

<file path=ppt/slides/_rels/slide1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8.xml"/><Relationship Id="rId3" Type="http://schemas.openxmlformats.org/officeDocument/2006/relationships/image" Target="../media/image6.png"/></Relationships>
</file>

<file path=ppt/slides/_rels/slide1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9.xml"/><Relationship Id="rId3" Type="http://schemas.openxmlformats.org/officeDocument/2006/relationships/image" Target="../media/image9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1.png"/></Relationships>
</file>

<file path=ppt/slides/_rels/slide2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20.xml"/><Relationship Id="rId3" Type="http://schemas.openxmlformats.org/officeDocument/2006/relationships/image" Target="../media/image5.png"/></Relationships>
</file>

<file path=ppt/slides/_rels/slide2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21.xml"/><Relationship Id="rId3" Type="http://schemas.openxmlformats.org/officeDocument/2006/relationships/image" Target="../media/image22.png"/></Relationships>
</file>

<file path=ppt/slides/_rels/slide2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22.xml"/><Relationship Id="rId3" Type="http://schemas.openxmlformats.org/officeDocument/2006/relationships/image" Target="../media/image21.pn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3.pn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16.png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18.png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20.png"/></Relationships>
</file>

<file path=ppt/slides/_rels/slide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19.png"/></Relationships>
</file>

<file path=ppt/slides/_rels/slide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10.png"/></Relationships>
</file>

<file path=ppt/slides/_rels/slide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/>
          <p:nvPr>
            <p:ph type="title"/>
          </p:nvPr>
        </p:nvSpPr>
        <p:spPr>
          <a:xfrm>
            <a:off x="311700" y="2285400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-GB" sz="2920"/>
              <a:t>Supplementary Tables and Figures</a:t>
            </a:r>
            <a:endParaRPr sz="292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98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Google Shape;99;p22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864213" y="152400"/>
            <a:ext cx="7415572" cy="483870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03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Google Shape;104;p2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900850" y="152400"/>
            <a:ext cx="7342305" cy="48387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08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" name="Google Shape;109;p2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947038" y="152400"/>
            <a:ext cx="7249930" cy="483869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3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Google Shape;114;p2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8743950" cy="37719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5" name="Google Shape;115;p25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214313" y="4076700"/>
            <a:ext cx="8715375" cy="8382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9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0" name="Google Shape;120;p2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71450" y="585788"/>
            <a:ext cx="8801100" cy="397192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24" name="Shape 1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5" name="Google Shape;125;p27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583338" y="152400"/>
            <a:ext cx="7977315" cy="48387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29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0" name="Google Shape;130;p28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868500" y="152400"/>
            <a:ext cx="7406996" cy="483870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34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5" name="Google Shape;135;p29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830013" y="152400"/>
            <a:ext cx="7483965" cy="48387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39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0" name="Google Shape;140;p30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727038" y="152400"/>
            <a:ext cx="7689928" cy="48387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44" name="Shape 1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5" name="Google Shape;145;p31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66700" y="190500"/>
            <a:ext cx="8610600" cy="47625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8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descr="Chart, treemap chart&#10;&#10;Description automatically generated" id="59" name="Google Shape;59;p1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2256775" y="86088"/>
            <a:ext cx="4832601" cy="497132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49" name="Shape 1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0" name="Google Shape;150;p32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38125" y="500063"/>
            <a:ext cx="8667750" cy="414337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54" name="Shape 1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5" name="Google Shape;155;p3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954800" y="152400"/>
            <a:ext cx="7234407" cy="483869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59" name="Shape 1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0" name="Google Shape;160;p3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71450" y="714375"/>
            <a:ext cx="8801100" cy="37147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63" name="Shape 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Google Shape;64;p1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817288" y="121100"/>
            <a:ext cx="7509424" cy="49013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Google Shape;69;p1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004851" y="332638"/>
            <a:ext cx="7134301" cy="447822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73" name="Shape 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Google Shape;74;p17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8772525" cy="482917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78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Google Shape;79;p18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85600" y="152400"/>
            <a:ext cx="7772805" cy="48387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p19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785375" y="152400"/>
            <a:ext cx="7573262" cy="48387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8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Google Shape;89;p20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78163" y="152400"/>
            <a:ext cx="7787680" cy="48387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93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Google Shape;94;p21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898763" y="152400"/>
            <a:ext cx="7346465" cy="48387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